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11" d="100"/>
          <a:sy n="111" d="100"/>
        </p:scale>
        <p:origin x="1416" y="-13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9900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3919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717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437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818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757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886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914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369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363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744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50D08-6FAF-4D7A-9CD5-5B21DB1B45AE}" type="datetimeFigureOut">
              <a:rPr kumimoji="1" lang="ja-JP" altLang="en-US" smtClean="0"/>
              <a:t>2017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6DE0A-3314-42EA-A854-44929F51FF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189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B822E4F3-E0AC-49E8-9269-5BD58FD87A7D}"/>
              </a:ext>
            </a:extLst>
          </p:cNvPr>
          <p:cNvSpPr txBox="1"/>
          <p:nvPr/>
        </p:nvSpPr>
        <p:spPr>
          <a:xfrm>
            <a:off x="478721" y="9069669"/>
            <a:ext cx="22862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Figure</a:t>
            </a:r>
            <a:r>
              <a:rPr lang="ja-JP" altLang="en-US" dirty="0"/>
              <a:t> </a:t>
            </a:r>
            <a:r>
              <a:rPr lang="en-US" altLang="ja-JP" dirty="0"/>
              <a:t>1</a:t>
            </a:r>
          </a:p>
          <a:p>
            <a:r>
              <a:rPr lang="en-US" altLang="ja-JP" dirty="0"/>
              <a:t>Matsuura R, et al</a:t>
            </a:r>
            <a:endParaRPr lang="ja-JP" altLang="en-US" dirty="0"/>
          </a:p>
        </p:txBody>
      </p: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id="{03CFE57D-9EDC-4CF8-817B-A34B9B3EB5F0}"/>
              </a:ext>
            </a:extLst>
          </p:cNvPr>
          <p:cNvGrpSpPr/>
          <p:nvPr/>
        </p:nvGrpSpPr>
        <p:grpSpPr>
          <a:xfrm>
            <a:off x="2110647" y="3540978"/>
            <a:ext cx="2636707" cy="2824044"/>
            <a:chOff x="2110647" y="3540978"/>
            <a:chExt cx="2636707" cy="2824044"/>
          </a:xfrm>
        </p:grpSpPr>
        <p:sp>
          <p:nvSpPr>
            <p:cNvPr id="13" name="Line 11">
              <a:extLst>
                <a:ext uri="{FF2B5EF4-FFF2-40B4-BE49-F238E27FC236}">
                  <a16:creationId xmlns:a16="http://schemas.microsoft.com/office/drawing/2014/main" id="{0CAC12BA-F5C2-41D2-9A69-AB29B15AAA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1200" y="5410184"/>
              <a:ext cx="31750" cy="0"/>
            </a:xfrm>
            <a:prstGeom prst="line">
              <a:avLst/>
            </a:prstGeom>
            <a:noFill/>
            <a:ln w="47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12">
              <a:extLst>
                <a:ext uri="{FF2B5EF4-FFF2-40B4-BE49-F238E27FC236}">
                  <a16:creationId xmlns:a16="http://schemas.microsoft.com/office/drawing/2014/main" id="{0E9FD2BD-AB17-44A4-AF14-202AF7062B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1200" y="5025749"/>
              <a:ext cx="31750" cy="0"/>
            </a:xfrm>
            <a:prstGeom prst="line">
              <a:avLst/>
            </a:prstGeom>
            <a:noFill/>
            <a:ln w="47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3">
              <a:extLst>
                <a:ext uri="{FF2B5EF4-FFF2-40B4-BE49-F238E27FC236}">
                  <a16:creationId xmlns:a16="http://schemas.microsoft.com/office/drawing/2014/main" id="{D59C26B5-DF0D-47A2-BD5B-5CD90F8B94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1200" y="4644508"/>
              <a:ext cx="31750" cy="0"/>
            </a:xfrm>
            <a:prstGeom prst="line">
              <a:avLst/>
            </a:prstGeom>
            <a:noFill/>
            <a:ln w="47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14">
              <a:extLst>
                <a:ext uri="{FF2B5EF4-FFF2-40B4-BE49-F238E27FC236}">
                  <a16:creationId xmlns:a16="http://schemas.microsoft.com/office/drawing/2014/main" id="{1A856931-269B-4464-A74C-B6B9702B48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1200" y="4263268"/>
              <a:ext cx="31750" cy="0"/>
            </a:xfrm>
            <a:prstGeom prst="line">
              <a:avLst/>
            </a:prstGeom>
            <a:noFill/>
            <a:ln w="47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Line 15">
              <a:extLst>
                <a:ext uri="{FF2B5EF4-FFF2-40B4-BE49-F238E27FC236}">
                  <a16:creationId xmlns:a16="http://schemas.microsoft.com/office/drawing/2014/main" id="{184DC0EF-3F44-4EBF-99AA-BA9C81AC8C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1200" y="3882027"/>
              <a:ext cx="31750" cy="0"/>
            </a:xfrm>
            <a:prstGeom prst="line">
              <a:avLst/>
            </a:prstGeom>
            <a:noFill/>
            <a:ln w="4763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" name="Rectangle 16">
              <a:extLst>
                <a:ext uri="{FF2B5EF4-FFF2-40B4-BE49-F238E27FC236}">
                  <a16:creationId xmlns:a16="http://schemas.microsoft.com/office/drawing/2014/main" id="{DB930F1F-E80D-44BF-9325-8C6492D466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5891" y="5362997"/>
              <a:ext cx="72135" cy="929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7">
              <a:extLst>
                <a:ext uri="{FF2B5EF4-FFF2-40B4-BE49-F238E27FC236}">
                  <a16:creationId xmlns:a16="http://schemas.microsoft.com/office/drawing/2014/main" id="{05FACBAE-D50F-41D3-A496-EC001CF0B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9485" y="4978562"/>
              <a:ext cx="288541" cy="929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00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8">
              <a:extLst>
                <a:ext uri="{FF2B5EF4-FFF2-40B4-BE49-F238E27FC236}">
                  <a16:creationId xmlns:a16="http://schemas.microsoft.com/office/drawing/2014/main" id="{5B6CCE73-2568-4C6E-AD9F-A7234ACD1E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9485" y="4597321"/>
              <a:ext cx="288541" cy="929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400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9">
              <a:extLst>
                <a:ext uri="{FF2B5EF4-FFF2-40B4-BE49-F238E27FC236}">
                  <a16:creationId xmlns:a16="http://schemas.microsoft.com/office/drawing/2014/main" id="{8FFC36A5-C2A3-4F4F-A426-E93B813ADC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9485" y="4216080"/>
              <a:ext cx="288541" cy="929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600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0">
              <a:extLst>
                <a:ext uri="{FF2B5EF4-FFF2-40B4-BE49-F238E27FC236}">
                  <a16:creationId xmlns:a16="http://schemas.microsoft.com/office/drawing/2014/main" id="{6BEB6D19-C171-4050-81D7-4AC131F373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9485" y="3835904"/>
              <a:ext cx="288541" cy="929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800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41" name="グループ化 40">
              <a:extLst>
                <a:ext uri="{FF2B5EF4-FFF2-40B4-BE49-F238E27FC236}">
                  <a16:creationId xmlns:a16="http://schemas.microsoft.com/office/drawing/2014/main" id="{902195A6-424D-4532-99C1-9D21CEDCEBDF}"/>
                </a:ext>
              </a:extLst>
            </p:cNvPr>
            <p:cNvGrpSpPr/>
            <p:nvPr/>
          </p:nvGrpSpPr>
          <p:grpSpPr>
            <a:xfrm>
              <a:off x="3041853" y="4246229"/>
              <a:ext cx="108000" cy="1163955"/>
              <a:chOff x="2359026" y="4306888"/>
              <a:chExt cx="508000" cy="1735137"/>
            </a:xfrm>
          </p:grpSpPr>
          <p:sp>
            <p:nvSpPr>
              <p:cNvPr id="24" name="Rectangle 22">
                <a:extLst>
                  <a:ext uri="{FF2B5EF4-FFF2-40B4-BE49-F238E27FC236}">
                    <a16:creationId xmlns:a16="http://schemas.microsoft.com/office/drawing/2014/main" id="{83D78C4F-C764-4082-8287-C3089D4618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9026" y="5135563"/>
                <a:ext cx="508000" cy="687388"/>
              </a:xfrm>
              <a:prstGeom prst="rect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" name="Line 23">
                <a:extLst>
                  <a:ext uri="{FF2B5EF4-FFF2-40B4-BE49-F238E27FC236}">
                    <a16:creationId xmlns:a16="http://schemas.microsoft.com/office/drawing/2014/main" id="{07F097CC-21A0-4DDC-8952-2F0B153F49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3026" y="4306888"/>
                <a:ext cx="0" cy="828675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" name="Line 24">
                <a:extLst>
                  <a:ext uri="{FF2B5EF4-FFF2-40B4-BE49-F238E27FC236}">
                    <a16:creationId xmlns:a16="http://schemas.microsoft.com/office/drawing/2014/main" id="{1BD7C720-F3E7-4F86-AB86-5CD911BD07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13026" y="5822950"/>
                <a:ext cx="0" cy="219075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" name="Line 25">
                <a:extLst>
                  <a:ext uri="{FF2B5EF4-FFF2-40B4-BE49-F238E27FC236}">
                    <a16:creationId xmlns:a16="http://schemas.microsoft.com/office/drawing/2014/main" id="{B1E5FC1E-AC61-4EEB-93F6-258A9234D0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59026" y="6042025"/>
                <a:ext cx="508000" cy="0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" name="Line 26">
                <a:extLst>
                  <a:ext uri="{FF2B5EF4-FFF2-40B4-BE49-F238E27FC236}">
                    <a16:creationId xmlns:a16="http://schemas.microsoft.com/office/drawing/2014/main" id="{E53666C6-4295-4272-A35B-B3ADA7542C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59026" y="4306888"/>
                <a:ext cx="508000" cy="0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" name="Line 27">
                <a:extLst>
                  <a:ext uri="{FF2B5EF4-FFF2-40B4-BE49-F238E27FC236}">
                    <a16:creationId xmlns:a16="http://schemas.microsoft.com/office/drawing/2014/main" id="{D28A38A6-B90E-479F-B8E9-84A9952636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359026" y="5567363"/>
                <a:ext cx="508000" cy="0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AFC431BA-2C20-4746-B60A-C7E2A9DEB4BD}"/>
                </a:ext>
              </a:extLst>
            </p:cNvPr>
            <p:cNvGrpSpPr/>
            <p:nvPr/>
          </p:nvGrpSpPr>
          <p:grpSpPr>
            <a:xfrm>
              <a:off x="3280295" y="5214239"/>
              <a:ext cx="108000" cy="192751"/>
              <a:chOff x="3659188" y="5749925"/>
              <a:chExt cx="508000" cy="287338"/>
            </a:xfrm>
          </p:grpSpPr>
          <p:sp>
            <p:nvSpPr>
              <p:cNvPr id="30" name="Rectangle 28">
                <a:extLst>
                  <a:ext uri="{FF2B5EF4-FFF2-40B4-BE49-F238E27FC236}">
                    <a16:creationId xmlns:a16="http://schemas.microsoft.com/office/drawing/2014/main" id="{C4AE35DB-7845-4C64-A24B-1674A6C3DA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9188" y="5891213"/>
                <a:ext cx="508000" cy="130175"/>
              </a:xfrm>
              <a:prstGeom prst="rect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" name="Line 29">
                <a:extLst>
                  <a:ext uri="{FF2B5EF4-FFF2-40B4-BE49-F238E27FC236}">
                    <a16:creationId xmlns:a16="http://schemas.microsoft.com/office/drawing/2014/main" id="{851B25CB-66BE-44B1-BD1A-E25A0A556D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3188" y="5749925"/>
                <a:ext cx="0" cy="141288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" name="Line 30">
                <a:extLst>
                  <a:ext uri="{FF2B5EF4-FFF2-40B4-BE49-F238E27FC236}">
                    <a16:creationId xmlns:a16="http://schemas.microsoft.com/office/drawing/2014/main" id="{A6F3FF6E-7A59-4695-ABA0-7793F0A45A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3188" y="6021388"/>
                <a:ext cx="0" cy="15875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" name="Line 31">
                <a:extLst>
                  <a:ext uri="{FF2B5EF4-FFF2-40B4-BE49-F238E27FC236}">
                    <a16:creationId xmlns:a16="http://schemas.microsoft.com/office/drawing/2014/main" id="{AE05368F-7EC4-4198-8F53-974204B2F7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59188" y="6037263"/>
                <a:ext cx="508000" cy="0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" name="Line 32">
                <a:extLst>
                  <a:ext uri="{FF2B5EF4-FFF2-40B4-BE49-F238E27FC236}">
                    <a16:creationId xmlns:a16="http://schemas.microsoft.com/office/drawing/2014/main" id="{112BF840-E22E-40E5-B130-5252539E56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59188" y="5749925"/>
                <a:ext cx="508000" cy="0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" name="Line 33">
                <a:extLst>
                  <a:ext uri="{FF2B5EF4-FFF2-40B4-BE49-F238E27FC236}">
                    <a16:creationId xmlns:a16="http://schemas.microsoft.com/office/drawing/2014/main" id="{8CD654D1-0A9E-4E07-937C-F6E4B118F9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59188" y="5989638"/>
                <a:ext cx="508000" cy="0"/>
              </a:xfrm>
              <a:prstGeom prst="line">
                <a:avLst/>
              </a:pr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2ABC5CB0-AA55-4588-A2B4-E1DF03899961}"/>
                </a:ext>
              </a:extLst>
            </p:cNvPr>
            <p:cNvCxnSpPr/>
            <p:nvPr/>
          </p:nvCxnSpPr>
          <p:spPr>
            <a:xfrm>
              <a:off x="2932950" y="3882824"/>
              <a:ext cx="0" cy="1544400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3815689F-E3D7-4AEC-ABD3-AAB41F71AF22}"/>
                </a:ext>
              </a:extLst>
            </p:cNvPr>
            <p:cNvCxnSpPr/>
            <p:nvPr/>
          </p:nvCxnSpPr>
          <p:spPr>
            <a:xfrm>
              <a:off x="2932950" y="5427224"/>
              <a:ext cx="540000" cy="0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6F78096A-8EB0-407F-853E-1EE3D2CB6D68}"/>
                </a:ext>
              </a:extLst>
            </p:cNvPr>
            <p:cNvSpPr txBox="1"/>
            <p:nvPr/>
          </p:nvSpPr>
          <p:spPr>
            <a:xfrm rot="18000000">
              <a:off x="2758725" y="5648189"/>
              <a:ext cx="960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Progression to </a:t>
              </a:r>
            </a:p>
            <a:p>
              <a:pPr algn="ctr"/>
              <a:r>
                <a:rPr kumimoji="1"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tage 3</a:t>
              </a:r>
              <a:endParaRPr kumimoji="1" lang="ja-JP" altLang="en-US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488E2769-5682-418F-9349-810B8DFD6A7A}"/>
                </a:ext>
              </a:extLst>
            </p:cNvPr>
            <p:cNvSpPr txBox="1"/>
            <p:nvPr/>
          </p:nvSpPr>
          <p:spPr>
            <a:xfrm rot="18000000">
              <a:off x="2342714" y="5724462"/>
              <a:ext cx="10502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Non-Progression</a:t>
              </a:r>
              <a:endParaRPr kumimoji="1" lang="ja-JP" altLang="en-US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9CD886DA-0549-42C8-ACD1-960B557D69FF}"/>
                </a:ext>
              </a:extLst>
            </p:cNvPr>
            <p:cNvSpPr txBox="1"/>
            <p:nvPr/>
          </p:nvSpPr>
          <p:spPr>
            <a:xfrm rot="16200000">
              <a:off x="1757391" y="4448380"/>
              <a:ext cx="1197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Weight-adjusted FR</a:t>
              </a:r>
            </a:p>
            <a:p>
              <a:pPr algn="ctr"/>
              <a:r>
                <a:rPr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(mL/mg/kg)</a:t>
              </a:r>
              <a:endParaRPr lang="ja-JP" altLang="en-US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4" name="Rectangle 42">
              <a:extLst>
                <a:ext uri="{FF2B5EF4-FFF2-40B4-BE49-F238E27FC236}">
                  <a16:creationId xmlns:a16="http://schemas.microsoft.com/office/drawing/2014/main" id="{7AA1670C-1484-473A-944C-E72DB98B02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7635" y="3886069"/>
              <a:ext cx="4763" cy="47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Rectangle 43">
              <a:extLst>
                <a:ext uri="{FF2B5EF4-FFF2-40B4-BE49-F238E27FC236}">
                  <a16:creationId xmlns:a16="http://schemas.microsoft.com/office/drawing/2014/main" id="{BB68F30A-6B4F-4DD4-A0E4-956C3E1769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7635" y="3886069"/>
              <a:ext cx="4763" cy="476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1937438D-DA50-4DD8-8870-CC2C26D5AF86}"/>
                </a:ext>
              </a:extLst>
            </p:cNvPr>
            <p:cNvSpPr txBox="1"/>
            <p:nvPr/>
          </p:nvSpPr>
          <p:spPr>
            <a:xfrm>
              <a:off x="2110647" y="3546979"/>
              <a:ext cx="3257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FCB7C058-A20E-4D31-87C1-AD0AFA5790BE}"/>
                </a:ext>
              </a:extLst>
            </p:cNvPr>
            <p:cNvSpPr txBox="1"/>
            <p:nvPr/>
          </p:nvSpPr>
          <p:spPr>
            <a:xfrm>
              <a:off x="3643979" y="3540978"/>
              <a:ext cx="3257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137">
              <a:extLst>
                <a:ext uri="{FF2B5EF4-FFF2-40B4-BE49-F238E27FC236}">
                  <a16:creationId xmlns:a16="http://schemas.microsoft.com/office/drawing/2014/main" id="{DCDE2499-D62B-49C1-83FE-820DF1C6AC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3042" y="3764391"/>
              <a:ext cx="3175" cy="350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Line 143">
              <a:extLst>
                <a:ext uri="{FF2B5EF4-FFF2-40B4-BE49-F238E27FC236}">
                  <a16:creationId xmlns:a16="http://schemas.microsoft.com/office/drawing/2014/main" id="{3875A1FB-BB10-447D-97A5-B4640660C3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304" y="5399799"/>
              <a:ext cx="19050" cy="0"/>
            </a:xfrm>
            <a:prstGeom prst="line">
              <a:avLst/>
            </a:prstGeom>
            <a:noFill/>
            <a:ln w="317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Line 144">
              <a:extLst>
                <a:ext uri="{FF2B5EF4-FFF2-40B4-BE49-F238E27FC236}">
                  <a16:creationId xmlns:a16="http://schemas.microsoft.com/office/drawing/2014/main" id="{23C1F73F-77B8-4DC7-B308-6E83582655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304" y="5007581"/>
              <a:ext cx="19050" cy="0"/>
            </a:xfrm>
            <a:prstGeom prst="line">
              <a:avLst/>
            </a:prstGeom>
            <a:noFill/>
            <a:ln w="317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Line 145">
              <a:extLst>
                <a:ext uri="{FF2B5EF4-FFF2-40B4-BE49-F238E27FC236}">
                  <a16:creationId xmlns:a16="http://schemas.microsoft.com/office/drawing/2014/main" id="{D55947F3-D522-4CA7-BAED-6B5FEFB61B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304" y="4618865"/>
              <a:ext cx="19050" cy="0"/>
            </a:xfrm>
            <a:prstGeom prst="line">
              <a:avLst/>
            </a:prstGeom>
            <a:noFill/>
            <a:ln w="317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Line 146">
              <a:extLst>
                <a:ext uri="{FF2B5EF4-FFF2-40B4-BE49-F238E27FC236}">
                  <a16:creationId xmlns:a16="http://schemas.microsoft.com/office/drawing/2014/main" id="{53516640-6A4A-48F7-9B2B-D9C837D6B5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304" y="4230149"/>
              <a:ext cx="19050" cy="0"/>
            </a:xfrm>
            <a:prstGeom prst="line">
              <a:avLst/>
            </a:prstGeom>
            <a:noFill/>
            <a:ln w="317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Line 147">
              <a:extLst>
                <a:ext uri="{FF2B5EF4-FFF2-40B4-BE49-F238E27FC236}">
                  <a16:creationId xmlns:a16="http://schemas.microsoft.com/office/drawing/2014/main" id="{AA871894-84E8-4319-99FE-965CE3A2E1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88304" y="3843185"/>
              <a:ext cx="19050" cy="0"/>
            </a:xfrm>
            <a:prstGeom prst="line">
              <a:avLst/>
            </a:prstGeom>
            <a:noFill/>
            <a:ln w="317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Rectangle 148">
              <a:extLst>
                <a:ext uri="{FF2B5EF4-FFF2-40B4-BE49-F238E27FC236}">
                  <a16:creationId xmlns:a16="http://schemas.microsoft.com/office/drawing/2014/main" id="{F67CD5A1-D1BD-4708-BFEF-B9CF2927FF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3785" y="5332721"/>
              <a:ext cx="7213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Rectangle 149">
              <a:extLst>
                <a:ext uri="{FF2B5EF4-FFF2-40B4-BE49-F238E27FC236}">
                  <a16:creationId xmlns:a16="http://schemas.microsoft.com/office/drawing/2014/main" id="{C294484B-015A-4EAF-9ABB-C0033AD334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380" y="4940503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200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Rectangle 150">
              <a:extLst>
                <a:ext uri="{FF2B5EF4-FFF2-40B4-BE49-F238E27FC236}">
                  <a16:creationId xmlns:a16="http://schemas.microsoft.com/office/drawing/2014/main" id="{008CC091-03BF-472E-81FF-2FD7B12424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380" y="4551788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4000</a:t>
              </a:r>
              <a:endPara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Rectangle 151">
              <a:extLst>
                <a:ext uri="{FF2B5EF4-FFF2-40B4-BE49-F238E27FC236}">
                  <a16:creationId xmlns:a16="http://schemas.microsoft.com/office/drawing/2014/main" id="{A30791A9-56F7-49D1-9B55-52DCE32BB7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380" y="4164824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60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" name="Rectangle 152">
              <a:extLst>
                <a:ext uri="{FF2B5EF4-FFF2-40B4-BE49-F238E27FC236}">
                  <a16:creationId xmlns:a16="http://schemas.microsoft.com/office/drawing/2014/main" id="{4025AF4A-8384-406D-AB00-3D7AE73728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7380" y="3776108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メイリオ" panose="020B0604030504040204" pitchFamily="50" charset="-128"/>
                  <a:ea typeface="メイリオ" panose="020B0604030504040204" pitchFamily="50" charset="-128"/>
                </a:rPr>
                <a:t>80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197" name="グループ化 196">
              <a:extLst>
                <a:ext uri="{FF2B5EF4-FFF2-40B4-BE49-F238E27FC236}">
                  <a16:creationId xmlns:a16="http://schemas.microsoft.com/office/drawing/2014/main" id="{AE01C2D9-688B-4ECA-A23E-0F85EF7070CC}"/>
                </a:ext>
              </a:extLst>
            </p:cNvPr>
            <p:cNvGrpSpPr/>
            <p:nvPr/>
          </p:nvGrpSpPr>
          <p:grpSpPr>
            <a:xfrm>
              <a:off x="4312764" y="4212640"/>
              <a:ext cx="108000" cy="1187159"/>
              <a:chOff x="3467100" y="7049073"/>
              <a:chExt cx="314325" cy="1187159"/>
            </a:xfrm>
          </p:grpSpPr>
          <p:sp>
            <p:nvSpPr>
              <p:cNvPr id="176" name="Rectangle 154">
                <a:extLst>
                  <a:ext uri="{FF2B5EF4-FFF2-40B4-BE49-F238E27FC236}">
                    <a16:creationId xmlns:a16="http://schemas.microsoft.com/office/drawing/2014/main" id="{19214B06-5AFA-430E-A0DE-5E82A4A547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7100" y="7612886"/>
                <a:ext cx="314325" cy="469260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7" name="Line 155">
                <a:extLst>
                  <a:ext uri="{FF2B5EF4-FFF2-40B4-BE49-F238E27FC236}">
                    <a16:creationId xmlns:a16="http://schemas.microsoft.com/office/drawing/2014/main" id="{C95E544F-0421-4143-A2BE-B8A97B4EBA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4263" y="7049073"/>
                <a:ext cx="0" cy="56381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" name="Line 156">
                <a:extLst>
                  <a:ext uri="{FF2B5EF4-FFF2-40B4-BE49-F238E27FC236}">
                    <a16:creationId xmlns:a16="http://schemas.microsoft.com/office/drawing/2014/main" id="{FF6839B9-6088-48A4-840F-19F2784A96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4263" y="8082146"/>
                <a:ext cx="0" cy="154086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" name="Line 157">
                <a:extLst>
                  <a:ext uri="{FF2B5EF4-FFF2-40B4-BE49-F238E27FC236}">
                    <a16:creationId xmlns:a16="http://schemas.microsoft.com/office/drawing/2014/main" id="{754F3696-759A-44DB-A7FF-5C27A76D76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67100" y="8236232"/>
                <a:ext cx="3143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" name="Line 158">
                <a:extLst>
                  <a:ext uri="{FF2B5EF4-FFF2-40B4-BE49-F238E27FC236}">
                    <a16:creationId xmlns:a16="http://schemas.microsoft.com/office/drawing/2014/main" id="{72F903E7-CC01-4E83-AE74-2AA67A659D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67100" y="7049073"/>
                <a:ext cx="3143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" name="Line 159">
                <a:extLst>
                  <a:ext uri="{FF2B5EF4-FFF2-40B4-BE49-F238E27FC236}">
                    <a16:creationId xmlns:a16="http://schemas.microsoft.com/office/drawing/2014/main" id="{7B5588D2-1B11-4A36-8157-26B3144082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467100" y="7907049"/>
                <a:ext cx="3143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198" name="グループ化 197">
              <a:extLst>
                <a:ext uri="{FF2B5EF4-FFF2-40B4-BE49-F238E27FC236}">
                  <a16:creationId xmlns:a16="http://schemas.microsoft.com/office/drawing/2014/main" id="{1A181DBC-10C5-4C16-8BD3-6D55687E675B}"/>
                </a:ext>
              </a:extLst>
            </p:cNvPr>
            <p:cNvGrpSpPr/>
            <p:nvPr/>
          </p:nvGrpSpPr>
          <p:grpSpPr>
            <a:xfrm>
              <a:off x="4579147" y="5200188"/>
              <a:ext cx="108000" cy="199611"/>
              <a:chOff x="4271963" y="8036621"/>
              <a:chExt cx="315912" cy="199611"/>
            </a:xfrm>
          </p:grpSpPr>
          <p:sp>
            <p:nvSpPr>
              <p:cNvPr id="182" name="Rectangle 160">
                <a:extLst>
                  <a:ext uri="{FF2B5EF4-FFF2-40B4-BE49-F238E27FC236}">
                    <a16:creationId xmlns:a16="http://schemas.microsoft.com/office/drawing/2014/main" id="{B9E33CF7-79A2-4698-9FB5-4211B783C5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71963" y="8136427"/>
                <a:ext cx="315912" cy="91051"/>
              </a:xfrm>
              <a:prstGeom prst="rect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" name="Line 161">
                <a:extLst>
                  <a:ext uri="{FF2B5EF4-FFF2-40B4-BE49-F238E27FC236}">
                    <a16:creationId xmlns:a16="http://schemas.microsoft.com/office/drawing/2014/main" id="{9AA16531-3D56-4ED2-8550-CB128EF9A7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0713" y="8036621"/>
                <a:ext cx="0" cy="99806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" name="Line 162">
                <a:extLst>
                  <a:ext uri="{FF2B5EF4-FFF2-40B4-BE49-F238E27FC236}">
                    <a16:creationId xmlns:a16="http://schemas.microsoft.com/office/drawing/2014/main" id="{6554001C-A1C5-4822-93B4-73F2F91B5F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30713" y="8227477"/>
                <a:ext cx="0" cy="875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" name="Line 163">
                <a:extLst>
                  <a:ext uri="{FF2B5EF4-FFF2-40B4-BE49-F238E27FC236}">
                    <a16:creationId xmlns:a16="http://schemas.microsoft.com/office/drawing/2014/main" id="{70EAC429-EB02-4FAA-99B3-D54C9E1784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271963" y="8236232"/>
                <a:ext cx="315912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" name="Line 164">
                <a:extLst>
                  <a:ext uri="{FF2B5EF4-FFF2-40B4-BE49-F238E27FC236}">
                    <a16:creationId xmlns:a16="http://schemas.microsoft.com/office/drawing/2014/main" id="{BA5D422C-6828-420E-A3EC-E194BA65A4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271963" y="8036621"/>
                <a:ext cx="315912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" name="Line 165">
                <a:extLst>
                  <a:ext uri="{FF2B5EF4-FFF2-40B4-BE49-F238E27FC236}">
                    <a16:creationId xmlns:a16="http://schemas.microsoft.com/office/drawing/2014/main" id="{241CE9AE-57FB-4DC6-86B2-FD2F55CE13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271963" y="8206466"/>
                <a:ext cx="315912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cxnSp>
          <p:nvCxnSpPr>
            <p:cNvPr id="194" name="直線コネクタ 193">
              <a:extLst>
                <a:ext uri="{FF2B5EF4-FFF2-40B4-BE49-F238E27FC236}">
                  <a16:creationId xmlns:a16="http://schemas.microsoft.com/office/drawing/2014/main" id="{BF415F48-7782-4E5D-A38B-5240671BCE2C}"/>
                </a:ext>
              </a:extLst>
            </p:cNvPr>
            <p:cNvCxnSpPr/>
            <p:nvPr/>
          </p:nvCxnSpPr>
          <p:spPr>
            <a:xfrm>
              <a:off x="4207354" y="3843185"/>
              <a:ext cx="0" cy="1584000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196" name="直線コネクタ 195">
              <a:extLst>
                <a:ext uri="{FF2B5EF4-FFF2-40B4-BE49-F238E27FC236}">
                  <a16:creationId xmlns:a16="http://schemas.microsoft.com/office/drawing/2014/main" id="{FF4434DD-4676-4069-865D-092608C405A5}"/>
                </a:ext>
              </a:extLst>
            </p:cNvPr>
            <p:cNvCxnSpPr/>
            <p:nvPr/>
          </p:nvCxnSpPr>
          <p:spPr>
            <a:xfrm>
              <a:off x="4207354" y="5427185"/>
              <a:ext cx="540000" cy="0"/>
            </a:xfrm>
            <a:prstGeom prst="lin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21A921AF-2B64-419F-8F51-4E4869A3F9AA}"/>
                </a:ext>
              </a:extLst>
            </p:cNvPr>
            <p:cNvSpPr txBox="1"/>
            <p:nvPr/>
          </p:nvSpPr>
          <p:spPr>
            <a:xfrm rot="18000000">
              <a:off x="3905151" y="5717234"/>
              <a:ext cx="10567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tage 3 </a:t>
              </a:r>
              <a:r>
                <a:rPr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or Death</a:t>
              </a:r>
              <a:endParaRPr kumimoji="1" lang="en-US" altLang="ja-JP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2BC93112-0AE1-49FA-9326-D92CB1BA828F}"/>
                </a:ext>
              </a:extLst>
            </p:cNvPr>
            <p:cNvSpPr txBox="1"/>
            <p:nvPr/>
          </p:nvSpPr>
          <p:spPr>
            <a:xfrm rot="18000000">
              <a:off x="3616754" y="5717234"/>
              <a:ext cx="10502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Non-Progression</a:t>
              </a:r>
              <a:endParaRPr kumimoji="1" lang="ja-JP" altLang="en-US" sz="9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cxnSp>
          <p:nvCxnSpPr>
            <p:cNvPr id="205" name="直線コネクタ 204">
              <a:extLst>
                <a:ext uri="{FF2B5EF4-FFF2-40B4-BE49-F238E27FC236}">
                  <a16:creationId xmlns:a16="http://schemas.microsoft.com/office/drawing/2014/main" id="{11421C38-F677-42A9-A285-115F1D669FDC}"/>
                </a:ext>
              </a:extLst>
            </p:cNvPr>
            <p:cNvCxnSpPr/>
            <p:nvPr/>
          </p:nvCxnSpPr>
          <p:spPr>
            <a:xfrm>
              <a:off x="3088327" y="4086385"/>
              <a:ext cx="255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E339DEE8-43F4-4BBA-A5C1-404591B62CAE}"/>
                </a:ext>
              </a:extLst>
            </p:cNvPr>
            <p:cNvSpPr txBox="1"/>
            <p:nvPr/>
          </p:nvSpPr>
          <p:spPr>
            <a:xfrm>
              <a:off x="3098947" y="3934861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*</a:t>
              </a:r>
              <a:endParaRPr kumimoji="1" lang="ja-JP" altLang="en-US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cxnSp>
          <p:nvCxnSpPr>
            <p:cNvPr id="207" name="直線コネクタ 206">
              <a:extLst>
                <a:ext uri="{FF2B5EF4-FFF2-40B4-BE49-F238E27FC236}">
                  <a16:creationId xmlns:a16="http://schemas.microsoft.com/office/drawing/2014/main" id="{B70FC609-D4A4-49F4-9758-E3F3A5D5E6EE}"/>
                </a:ext>
              </a:extLst>
            </p:cNvPr>
            <p:cNvCxnSpPr/>
            <p:nvPr/>
          </p:nvCxnSpPr>
          <p:spPr>
            <a:xfrm>
              <a:off x="4372978" y="4086872"/>
              <a:ext cx="2556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67F89323-2C63-4ACD-9E7B-28AE14917F5B}"/>
                </a:ext>
              </a:extLst>
            </p:cNvPr>
            <p:cNvSpPr txBox="1"/>
            <p:nvPr/>
          </p:nvSpPr>
          <p:spPr>
            <a:xfrm>
              <a:off x="4383598" y="3935348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*</a:t>
              </a:r>
              <a:endParaRPr kumimoji="1" lang="ja-JP" altLang="en-US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07467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0" name="グループ化 159">
            <a:extLst>
              <a:ext uri="{FF2B5EF4-FFF2-40B4-BE49-F238E27FC236}">
                <a16:creationId xmlns:a16="http://schemas.microsoft.com/office/drawing/2014/main" id="{37673133-2B73-4DD2-B59B-E1EB0948E7B1}"/>
              </a:ext>
            </a:extLst>
          </p:cNvPr>
          <p:cNvGrpSpPr/>
          <p:nvPr/>
        </p:nvGrpSpPr>
        <p:grpSpPr>
          <a:xfrm>
            <a:off x="1120870" y="3777615"/>
            <a:ext cx="4616261" cy="2350771"/>
            <a:chOff x="960579" y="3540978"/>
            <a:chExt cx="4616261" cy="2350771"/>
          </a:xfrm>
        </p:grpSpPr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43E2E07C-E2C8-480B-80D5-C0081E2C00BF}"/>
                </a:ext>
              </a:extLst>
            </p:cNvPr>
            <p:cNvGrpSpPr/>
            <p:nvPr/>
          </p:nvGrpSpPr>
          <p:grpSpPr>
            <a:xfrm>
              <a:off x="1070956" y="3870215"/>
              <a:ext cx="2020351" cy="2021534"/>
              <a:chOff x="3045003" y="3736996"/>
              <a:chExt cx="2020351" cy="2021534"/>
            </a:xfrm>
          </p:grpSpPr>
          <p:sp>
            <p:nvSpPr>
              <p:cNvPr id="24" name="Line 56">
                <a:extLst>
                  <a:ext uri="{FF2B5EF4-FFF2-40B4-BE49-F238E27FC236}">
                    <a16:creationId xmlns:a16="http://schemas.microsoft.com/office/drawing/2014/main" id="{7188B7E5-AFC6-478C-A350-E1E3BEC2FE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0750" y="5292725"/>
                <a:ext cx="30163" cy="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" name="Line 61">
                <a:extLst>
                  <a:ext uri="{FF2B5EF4-FFF2-40B4-BE49-F238E27FC236}">
                    <a16:creationId xmlns:a16="http://schemas.microsoft.com/office/drawing/2014/main" id="{C8C987EF-D857-4D70-8401-F87B903733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0750" y="4546600"/>
                <a:ext cx="30163" cy="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" name="Line 66">
                <a:extLst>
                  <a:ext uri="{FF2B5EF4-FFF2-40B4-BE49-F238E27FC236}">
                    <a16:creationId xmlns:a16="http://schemas.microsoft.com/office/drawing/2014/main" id="{027C6845-249C-4132-8678-8054C6B634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0750" y="3805238"/>
                <a:ext cx="30163" cy="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" name="Rectangle 67">
                <a:extLst>
                  <a:ext uri="{FF2B5EF4-FFF2-40B4-BE49-F238E27FC236}">
                    <a16:creationId xmlns:a16="http://schemas.microsoft.com/office/drawing/2014/main" id="{00299D9C-4ABF-446D-8D7A-DE79D63C1F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76722" y="5224483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" name="Rectangle 72">
                <a:extLst>
                  <a:ext uri="{FF2B5EF4-FFF2-40B4-BE49-F238E27FC236}">
                    <a16:creationId xmlns:a16="http://schemas.microsoft.com/office/drawing/2014/main" id="{DDADEDC8-57D1-49B8-A989-F2A1411FB0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76722" y="4478358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5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" name="Rectangle 77">
                <a:extLst>
                  <a:ext uri="{FF2B5EF4-FFF2-40B4-BE49-F238E27FC236}">
                    <a16:creationId xmlns:a16="http://schemas.microsoft.com/office/drawing/2014/main" id="{91B68B62-B013-4F13-B900-091BD9ED2C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76722" y="3736996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" name="Line 79">
                <a:extLst>
                  <a:ext uri="{FF2B5EF4-FFF2-40B4-BE49-F238E27FC236}">
                    <a16:creationId xmlns:a16="http://schemas.microsoft.com/office/drawing/2014/main" id="{3E53522F-958F-4BC8-9C14-1AE8A38F3B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0913" y="3805238"/>
                <a:ext cx="0" cy="1487487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" name="Line 89">
                <a:extLst>
                  <a:ext uri="{FF2B5EF4-FFF2-40B4-BE49-F238E27FC236}">
                    <a16:creationId xmlns:a16="http://schemas.microsoft.com/office/drawing/2014/main" id="{CF30B360-130B-41B6-B468-892C4F7339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970463" y="3805238"/>
                <a:ext cx="0" cy="1487487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" name="Line 90">
                <a:extLst>
                  <a:ext uri="{FF2B5EF4-FFF2-40B4-BE49-F238E27FC236}">
                    <a16:creationId xmlns:a16="http://schemas.microsoft.com/office/drawing/2014/main" id="{9C29D3B6-090F-4B39-82B6-827F541764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0913" y="5292725"/>
                <a:ext cx="1479550" cy="0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" name="Line 100">
                <a:extLst>
                  <a:ext uri="{FF2B5EF4-FFF2-40B4-BE49-F238E27FC236}">
                    <a16:creationId xmlns:a16="http://schemas.microsoft.com/office/drawing/2014/main" id="{6CA68073-DAEA-45C8-843C-28B5B8D124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0913" y="3805238"/>
                <a:ext cx="1479550" cy="0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" name="Freeform 102">
                <a:extLst>
                  <a:ext uri="{FF2B5EF4-FFF2-40B4-BE49-F238E27FC236}">
                    <a16:creationId xmlns:a16="http://schemas.microsoft.com/office/drawing/2014/main" id="{4FF8FEE2-A678-42EE-9A0B-E7EBCB5C9D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90913" y="3805238"/>
                <a:ext cx="1479550" cy="1487487"/>
              </a:xfrm>
              <a:custGeom>
                <a:avLst/>
                <a:gdLst>
                  <a:gd name="T0" fmla="*/ 12 w 932"/>
                  <a:gd name="T1" fmla="*/ 937 h 937"/>
                  <a:gd name="T2" fmla="*/ 25 w 932"/>
                  <a:gd name="T3" fmla="*/ 882 h 937"/>
                  <a:gd name="T4" fmla="*/ 25 w 932"/>
                  <a:gd name="T5" fmla="*/ 772 h 937"/>
                  <a:gd name="T6" fmla="*/ 37 w 932"/>
                  <a:gd name="T7" fmla="*/ 717 h 937"/>
                  <a:gd name="T8" fmla="*/ 37 w 932"/>
                  <a:gd name="T9" fmla="*/ 606 h 937"/>
                  <a:gd name="T10" fmla="*/ 37 w 932"/>
                  <a:gd name="T11" fmla="*/ 496 h 937"/>
                  <a:gd name="T12" fmla="*/ 37 w 932"/>
                  <a:gd name="T13" fmla="*/ 386 h 937"/>
                  <a:gd name="T14" fmla="*/ 49 w 932"/>
                  <a:gd name="T15" fmla="*/ 331 h 937"/>
                  <a:gd name="T16" fmla="*/ 62 w 932"/>
                  <a:gd name="T17" fmla="*/ 276 h 937"/>
                  <a:gd name="T18" fmla="*/ 86 w 932"/>
                  <a:gd name="T19" fmla="*/ 276 h 937"/>
                  <a:gd name="T20" fmla="*/ 111 w 932"/>
                  <a:gd name="T21" fmla="*/ 276 h 937"/>
                  <a:gd name="T22" fmla="*/ 135 w 932"/>
                  <a:gd name="T23" fmla="*/ 276 h 937"/>
                  <a:gd name="T24" fmla="*/ 160 w 932"/>
                  <a:gd name="T25" fmla="*/ 276 h 937"/>
                  <a:gd name="T26" fmla="*/ 172 w 932"/>
                  <a:gd name="T27" fmla="*/ 221 h 937"/>
                  <a:gd name="T28" fmla="*/ 196 w 932"/>
                  <a:gd name="T29" fmla="*/ 221 h 937"/>
                  <a:gd name="T30" fmla="*/ 209 w 932"/>
                  <a:gd name="T31" fmla="*/ 165 h 937"/>
                  <a:gd name="T32" fmla="*/ 233 w 932"/>
                  <a:gd name="T33" fmla="*/ 165 h 937"/>
                  <a:gd name="T34" fmla="*/ 258 w 932"/>
                  <a:gd name="T35" fmla="*/ 165 h 937"/>
                  <a:gd name="T36" fmla="*/ 282 w 932"/>
                  <a:gd name="T37" fmla="*/ 165 h 937"/>
                  <a:gd name="T38" fmla="*/ 307 w 932"/>
                  <a:gd name="T39" fmla="*/ 165 h 937"/>
                  <a:gd name="T40" fmla="*/ 331 w 932"/>
                  <a:gd name="T41" fmla="*/ 165 h 937"/>
                  <a:gd name="T42" fmla="*/ 356 w 932"/>
                  <a:gd name="T43" fmla="*/ 165 h 937"/>
                  <a:gd name="T44" fmla="*/ 368 w 932"/>
                  <a:gd name="T45" fmla="*/ 110 h 937"/>
                  <a:gd name="T46" fmla="*/ 392 w 932"/>
                  <a:gd name="T47" fmla="*/ 110 h 937"/>
                  <a:gd name="T48" fmla="*/ 405 w 932"/>
                  <a:gd name="T49" fmla="*/ 55 h 937"/>
                  <a:gd name="T50" fmla="*/ 429 w 932"/>
                  <a:gd name="T51" fmla="*/ 55 h 937"/>
                  <a:gd name="T52" fmla="*/ 454 w 932"/>
                  <a:gd name="T53" fmla="*/ 55 h 937"/>
                  <a:gd name="T54" fmla="*/ 478 w 932"/>
                  <a:gd name="T55" fmla="*/ 55 h 937"/>
                  <a:gd name="T56" fmla="*/ 503 w 932"/>
                  <a:gd name="T57" fmla="*/ 55 h 937"/>
                  <a:gd name="T58" fmla="*/ 527 w 932"/>
                  <a:gd name="T59" fmla="*/ 55 h 937"/>
                  <a:gd name="T60" fmla="*/ 552 w 932"/>
                  <a:gd name="T61" fmla="*/ 55 h 937"/>
                  <a:gd name="T62" fmla="*/ 576 w 932"/>
                  <a:gd name="T63" fmla="*/ 55 h 937"/>
                  <a:gd name="T64" fmla="*/ 601 w 932"/>
                  <a:gd name="T65" fmla="*/ 55 h 937"/>
                  <a:gd name="T66" fmla="*/ 625 w 932"/>
                  <a:gd name="T67" fmla="*/ 55 h 937"/>
                  <a:gd name="T68" fmla="*/ 650 w 932"/>
                  <a:gd name="T69" fmla="*/ 55 h 937"/>
                  <a:gd name="T70" fmla="*/ 674 w 932"/>
                  <a:gd name="T71" fmla="*/ 55 h 937"/>
                  <a:gd name="T72" fmla="*/ 699 w 932"/>
                  <a:gd name="T73" fmla="*/ 55 h 937"/>
                  <a:gd name="T74" fmla="*/ 723 w 932"/>
                  <a:gd name="T75" fmla="*/ 55 h 937"/>
                  <a:gd name="T76" fmla="*/ 748 w 932"/>
                  <a:gd name="T77" fmla="*/ 55 h 937"/>
                  <a:gd name="T78" fmla="*/ 760 w 932"/>
                  <a:gd name="T79" fmla="*/ 0 h 937"/>
                  <a:gd name="T80" fmla="*/ 785 w 932"/>
                  <a:gd name="T81" fmla="*/ 0 h 937"/>
                  <a:gd name="T82" fmla="*/ 809 w 932"/>
                  <a:gd name="T83" fmla="*/ 0 h 937"/>
                  <a:gd name="T84" fmla="*/ 834 w 932"/>
                  <a:gd name="T85" fmla="*/ 0 h 937"/>
                  <a:gd name="T86" fmla="*/ 858 w 932"/>
                  <a:gd name="T87" fmla="*/ 0 h 937"/>
                  <a:gd name="T88" fmla="*/ 883 w 932"/>
                  <a:gd name="T89" fmla="*/ 0 h 937"/>
                  <a:gd name="T90" fmla="*/ 907 w 932"/>
                  <a:gd name="T91" fmla="*/ 0 h 937"/>
                  <a:gd name="T92" fmla="*/ 932 w 932"/>
                  <a:gd name="T93" fmla="*/ 0 h 9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932" h="937">
                    <a:moveTo>
                      <a:pt x="0" y="937"/>
                    </a:moveTo>
                    <a:lnTo>
                      <a:pt x="12" y="937"/>
                    </a:lnTo>
                    <a:lnTo>
                      <a:pt x="25" y="937"/>
                    </a:lnTo>
                    <a:lnTo>
                      <a:pt x="25" y="882"/>
                    </a:lnTo>
                    <a:lnTo>
                      <a:pt x="25" y="827"/>
                    </a:lnTo>
                    <a:lnTo>
                      <a:pt x="25" y="772"/>
                    </a:lnTo>
                    <a:lnTo>
                      <a:pt x="25" y="717"/>
                    </a:lnTo>
                    <a:lnTo>
                      <a:pt x="37" y="717"/>
                    </a:lnTo>
                    <a:lnTo>
                      <a:pt x="37" y="661"/>
                    </a:lnTo>
                    <a:lnTo>
                      <a:pt x="37" y="606"/>
                    </a:lnTo>
                    <a:lnTo>
                      <a:pt x="37" y="551"/>
                    </a:lnTo>
                    <a:lnTo>
                      <a:pt x="37" y="496"/>
                    </a:lnTo>
                    <a:lnTo>
                      <a:pt x="37" y="441"/>
                    </a:lnTo>
                    <a:lnTo>
                      <a:pt x="37" y="386"/>
                    </a:lnTo>
                    <a:lnTo>
                      <a:pt x="49" y="386"/>
                    </a:lnTo>
                    <a:lnTo>
                      <a:pt x="49" y="331"/>
                    </a:lnTo>
                    <a:lnTo>
                      <a:pt x="49" y="276"/>
                    </a:lnTo>
                    <a:lnTo>
                      <a:pt x="62" y="276"/>
                    </a:lnTo>
                    <a:lnTo>
                      <a:pt x="74" y="276"/>
                    </a:lnTo>
                    <a:lnTo>
                      <a:pt x="86" y="276"/>
                    </a:lnTo>
                    <a:lnTo>
                      <a:pt x="98" y="276"/>
                    </a:lnTo>
                    <a:lnTo>
                      <a:pt x="111" y="276"/>
                    </a:lnTo>
                    <a:lnTo>
                      <a:pt x="123" y="276"/>
                    </a:lnTo>
                    <a:lnTo>
                      <a:pt x="135" y="276"/>
                    </a:lnTo>
                    <a:lnTo>
                      <a:pt x="147" y="276"/>
                    </a:lnTo>
                    <a:lnTo>
                      <a:pt x="160" y="276"/>
                    </a:lnTo>
                    <a:lnTo>
                      <a:pt x="172" y="276"/>
                    </a:lnTo>
                    <a:lnTo>
                      <a:pt x="172" y="221"/>
                    </a:lnTo>
                    <a:lnTo>
                      <a:pt x="184" y="221"/>
                    </a:lnTo>
                    <a:lnTo>
                      <a:pt x="196" y="221"/>
                    </a:lnTo>
                    <a:lnTo>
                      <a:pt x="196" y="165"/>
                    </a:lnTo>
                    <a:lnTo>
                      <a:pt x="209" y="165"/>
                    </a:lnTo>
                    <a:lnTo>
                      <a:pt x="221" y="165"/>
                    </a:lnTo>
                    <a:lnTo>
                      <a:pt x="233" y="165"/>
                    </a:lnTo>
                    <a:lnTo>
                      <a:pt x="245" y="165"/>
                    </a:lnTo>
                    <a:lnTo>
                      <a:pt x="258" y="165"/>
                    </a:lnTo>
                    <a:lnTo>
                      <a:pt x="270" y="165"/>
                    </a:lnTo>
                    <a:lnTo>
                      <a:pt x="282" y="165"/>
                    </a:lnTo>
                    <a:lnTo>
                      <a:pt x="294" y="165"/>
                    </a:lnTo>
                    <a:lnTo>
                      <a:pt x="307" y="165"/>
                    </a:lnTo>
                    <a:lnTo>
                      <a:pt x="319" y="165"/>
                    </a:lnTo>
                    <a:lnTo>
                      <a:pt x="331" y="165"/>
                    </a:lnTo>
                    <a:lnTo>
                      <a:pt x="343" y="165"/>
                    </a:lnTo>
                    <a:lnTo>
                      <a:pt x="356" y="165"/>
                    </a:lnTo>
                    <a:lnTo>
                      <a:pt x="356" y="110"/>
                    </a:lnTo>
                    <a:lnTo>
                      <a:pt x="368" y="110"/>
                    </a:lnTo>
                    <a:lnTo>
                      <a:pt x="380" y="110"/>
                    </a:lnTo>
                    <a:lnTo>
                      <a:pt x="392" y="110"/>
                    </a:lnTo>
                    <a:lnTo>
                      <a:pt x="405" y="110"/>
                    </a:lnTo>
                    <a:lnTo>
                      <a:pt x="405" y="55"/>
                    </a:lnTo>
                    <a:lnTo>
                      <a:pt x="417" y="55"/>
                    </a:lnTo>
                    <a:lnTo>
                      <a:pt x="429" y="55"/>
                    </a:lnTo>
                    <a:lnTo>
                      <a:pt x="441" y="55"/>
                    </a:lnTo>
                    <a:lnTo>
                      <a:pt x="454" y="55"/>
                    </a:lnTo>
                    <a:lnTo>
                      <a:pt x="466" y="55"/>
                    </a:lnTo>
                    <a:lnTo>
                      <a:pt x="478" y="55"/>
                    </a:lnTo>
                    <a:lnTo>
                      <a:pt x="490" y="55"/>
                    </a:lnTo>
                    <a:lnTo>
                      <a:pt x="503" y="55"/>
                    </a:lnTo>
                    <a:lnTo>
                      <a:pt x="515" y="55"/>
                    </a:lnTo>
                    <a:lnTo>
                      <a:pt x="527" y="55"/>
                    </a:lnTo>
                    <a:lnTo>
                      <a:pt x="539" y="55"/>
                    </a:lnTo>
                    <a:lnTo>
                      <a:pt x="552" y="55"/>
                    </a:lnTo>
                    <a:lnTo>
                      <a:pt x="564" y="55"/>
                    </a:lnTo>
                    <a:lnTo>
                      <a:pt x="576" y="55"/>
                    </a:lnTo>
                    <a:lnTo>
                      <a:pt x="589" y="55"/>
                    </a:lnTo>
                    <a:lnTo>
                      <a:pt x="601" y="55"/>
                    </a:lnTo>
                    <a:lnTo>
                      <a:pt x="613" y="55"/>
                    </a:lnTo>
                    <a:lnTo>
                      <a:pt x="625" y="55"/>
                    </a:lnTo>
                    <a:lnTo>
                      <a:pt x="638" y="55"/>
                    </a:lnTo>
                    <a:lnTo>
                      <a:pt x="650" y="55"/>
                    </a:lnTo>
                    <a:lnTo>
                      <a:pt x="662" y="55"/>
                    </a:lnTo>
                    <a:lnTo>
                      <a:pt x="674" y="55"/>
                    </a:lnTo>
                    <a:lnTo>
                      <a:pt x="687" y="55"/>
                    </a:lnTo>
                    <a:lnTo>
                      <a:pt x="699" y="55"/>
                    </a:lnTo>
                    <a:lnTo>
                      <a:pt x="711" y="55"/>
                    </a:lnTo>
                    <a:lnTo>
                      <a:pt x="723" y="55"/>
                    </a:lnTo>
                    <a:lnTo>
                      <a:pt x="736" y="55"/>
                    </a:lnTo>
                    <a:lnTo>
                      <a:pt x="748" y="55"/>
                    </a:lnTo>
                    <a:lnTo>
                      <a:pt x="748" y="0"/>
                    </a:lnTo>
                    <a:lnTo>
                      <a:pt x="760" y="0"/>
                    </a:lnTo>
                    <a:lnTo>
                      <a:pt x="772" y="0"/>
                    </a:lnTo>
                    <a:lnTo>
                      <a:pt x="785" y="0"/>
                    </a:lnTo>
                    <a:lnTo>
                      <a:pt x="797" y="0"/>
                    </a:lnTo>
                    <a:lnTo>
                      <a:pt x="809" y="0"/>
                    </a:lnTo>
                    <a:lnTo>
                      <a:pt x="821" y="0"/>
                    </a:lnTo>
                    <a:lnTo>
                      <a:pt x="834" y="0"/>
                    </a:lnTo>
                    <a:lnTo>
                      <a:pt x="846" y="0"/>
                    </a:lnTo>
                    <a:lnTo>
                      <a:pt x="858" y="0"/>
                    </a:lnTo>
                    <a:lnTo>
                      <a:pt x="870" y="0"/>
                    </a:lnTo>
                    <a:lnTo>
                      <a:pt x="883" y="0"/>
                    </a:lnTo>
                    <a:lnTo>
                      <a:pt x="895" y="0"/>
                    </a:lnTo>
                    <a:lnTo>
                      <a:pt x="907" y="0"/>
                    </a:lnTo>
                    <a:lnTo>
                      <a:pt x="919" y="0"/>
                    </a:lnTo>
                    <a:lnTo>
                      <a:pt x="932" y="0"/>
                    </a:lnTo>
                    <a:lnTo>
                      <a:pt x="932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" name="Rectangle 103">
                <a:extLst>
                  <a:ext uri="{FF2B5EF4-FFF2-40B4-BE49-F238E27FC236}">
                    <a16:creationId xmlns:a16="http://schemas.microsoft.com/office/drawing/2014/main" id="{B07332D0-11EE-4896-A4F4-55C5381111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0913" y="3805238"/>
                <a:ext cx="1479550" cy="1487487"/>
              </a:xfrm>
              <a:prstGeom prst="rect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" name="Line 114">
                <a:extLst>
                  <a:ext uri="{FF2B5EF4-FFF2-40B4-BE49-F238E27FC236}">
                    <a16:creationId xmlns:a16="http://schemas.microsoft.com/office/drawing/2014/main" id="{18FAB158-532D-4294-8413-B6DD0F8876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0913" y="5292725"/>
                <a:ext cx="0" cy="3175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" name="Line 119">
                <a:extLst>
                  <a:ext uri="{FF2B5EF4-FFF2-40B4-BE49-F238E27FC236}">
                    <a16:creationId xmlns:a16="http://schemas.microsoft.com/office/drawing/2014/main" id="{C39CED21-DC03-4CB0-9CD1-8CA4E1273F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33863" y="5292725"/>
                <a:ext cx="0" cy="3175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" name="Line 124">
                <a:extLst>
                  <a:ext uri="{FF2B5EF4-FFF2-40B4-BE49-F238E27FC236}">
                    <a16:creationId xmlns:a16="http://schemas.microsoft.com/office/drawing/2014/main" id="{F6A0B412-9683-4197-87DB-CE46558310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70463" y="5292725"/>
                <a:ext cx="0" cy="3175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" name="Rectangle 125">
                <a:extLst>
                  <a:ext uri="{FF2B5EF4-FFF2-40B4-BE49-F238E27FC236}">
                    <a16:creationId xmlns:a16="http://schemas.microsoft.com/office/drawing/2014/main" id="{791DC350-43B4-412C-A18B-39FF44CFEF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9236" y="5322888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" name="Rectangle 130">
                <a:extLst>
                  <a:ext uri="{FF2B5EF4-FFF2-40B4-BE49-F238E27FC236}">
                    <a16:creationId xmlns:a16="http://schemas.microsoft.com/office/drawing/2014/main" id="{E08ABC49-4CB6-462A-BC31-E6236B69B8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1008" y="5322888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1" name="Rectangle 72">
                <a:extLst>
                  <a:ext uri="{FF2B5EF4-FFF2-40B4-BE49-F238E27FC236}">
                    <a16:creationId xmlns:a16="http://schemas.microsoft.com/office/drawing/2014/main" id="{51AF1508-BFEF-41B7-939F-9D03E9E495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40559" y="5316855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5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" name="Rectangle 37">
                <a:extLst>
                  <a:ext uri="{FF2B5EF4-FFF2-40B4-BE49-F238E27FC236}">
                    <a16:creationId xmlns:a16="http://schemas.microsoft.com/office/drawing/2014/main" id="{581CCFAE-3202-455E-8468-12B40BCB03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9882" y="5604642"/>
                <a:ext cx="68929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1-Specificity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43" name="Rectangle 6">
                <a:extLst>
                  <a:ext uri="{FF2B5EF4-FFF2-40B4-BE49-F238E27FC236}">
                    <a16:creationId xmlns:a16="http://schemas.microsoft.com/office/drawing/2014/main" id="{DB2709C8-259A-4567-B081-E7F210D503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834207" y="4475229"/>
                <a:ext cx="5754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S</a:t>
                </a: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ensitivity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F8D17B21-15B4-4A76-BFAE-6067FBF766A2}"/>
                </a:ext>
              </a:extLst>
            </p:cNvPr>
            <p:cNvSpPr txBox="1"/>
            <p:nvPr/>
          </p:nvSpPr>
          <p:spPr>
            <a:xfrm>
              <a:off x="1937402" y="4944805"/>
              <a:ext cx="104547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AUC: </a:t>
              </a:r>
              <a:br>
                <a:rPr kumimoji="1" lang="en-US" altLang="ja-JP" sz="1000" dirty="0"/>
              </a:br>
              <a:r>
                <a:rPr lang="en-US" altLang="ja-JP" sz="1000" dirty="0"/>
                <a:t>0.85 [0.71–0.93]</a:t>
              </a:r>
              <a:endParaRPr kumimoji="1" lang="ja-JP" altLang="en-US" sz="1000" dirty="0"/>
            </a:p>
          </p:txBody>
        </p:sp>
        <p:grpSp>
          <p:nvGrpSpPr>
            <p:cNvPr id="156" name="グループ化 155">
              <a:extLst>
                <a:ext uri="{FF2B5EF4-FFF2-40B4-BE49-F238E27FC236}">
                  <a16:creationId xmlns:a16="http://schemas.microsoft.com/office/drawing/2014/main" id="{46DA5053-DBFC-4663-A8EB-8ECC22526114}"/>
                </a:ext>
              </a:extLst>
            </p:cNvPr>
            <p:cNvGrpSpPr/>
            <p:nvPr/>
          </p:nvGrpSpPr>
          <p:grpSpPr>
            <a:xfrm>
              <a:off x="3556489" y="3870215"/>
              <a:ext cx="2020351" cy="2021534"/>
              <a:chOff x="3556489" y="3862357"/>
              <a:chExt cx="2020351" cy="2021534"/>
            </a:xfrm>
          </p:grpSpPr>
          <p:sp>
            <p:nvSpPr>
              <p:cNvPr id="62" name="Line 19">
                <a:extLst>
                  <a:ext uri="{FF2B5EF4-FFF2-40B4-BE49-F238E27FC236}">
                    <a16:creationId xmlns:a16="http://schemas.microsoft.com/office/drawing/2014/main" id="{8F4B31A0-4E22-4B2D-8C90-7F009EB982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1925" y="5413375"/>
                <a:ext cx="30163" cy="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7" name="Line 24">
                <a:extLst>
                  <a:ext uri="{FF2B5EF4-FFF2-40B4-BE49-F238E27FC236}">
                    <a16:creationId xmlns:a16="http://schemas.microsoft.com/office/drawing/2014/main" id="{BE5189E9-B051-4180-A7F0-7E324A63AD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1925" y="4667250"/>
                <a:ext cx="30163" cy="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2" name="Line 29">
                <a:extLst>
                  <a:ext uri="{FF2B5EF4-FFF2-40B4-BE49-F238E27FC236}">
                    <a16:creationId xmlns:a16="http://schemas.microsoft.com/office/drawing/2014/main" id="{4E8EE542-0449-4834-90E5-5E8F2E2ACB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1925" y="3927475"/>
                <a:ext cx="30163" cy="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" name="Line 42">
                <a:extLst>
                  <a:ext uri="{FF2B5EF4-FFF2-40B4-BE49-F238E27FC236}">
                    <a16:creationId xmlns:a16="http://schemas.microsoft.com/office/drawing/2014/main" id="{E0F452BC-3DC6-41BF-B445-AE26E7BBF2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02088" y="3927475"/>
                <a:ext cx="0" cy="1485900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5" name="Line 52">
                <a:extLst>
                  <a:ext uri="{FF2B5EF4-FFF2-40B4-BE49-F238E27FC236}">
                    <a16:creationId xmlns:a16="http://schemas.microsoft.com/office/drawing/2014/main" id="{D774BD8E-6CA9-436D-835B-7186FDCD51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81638" y="3927475"/>
                <a:ext cx="0" cy="1485900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6" name="Line 53">
                <a:extLst>
                  <a:ext uri="{FF2B5EF4-FFF2-40B4-BE49-F238E27FC236}">
                    <a16:creationId xmlns:a16="http://schemas.microsoft.com/office/drawing/2014/main" id="{9DFBF172-6BCE-477B-932D-87755674F2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088" y="5413375"/>
                <a:ext cx="1479550" cy="0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6" name="Line 63">
                <a:extLst>
                  <a:ext uri="{FF2B5EF4-FFF2-40B4-BE49-F238E27FC236}">
                    <a16:creationId xmlns:a16="http://schemas.microsoft.com/office/drawing/2014/main" id="{9D098BA8-E836-430E-9FDE-052D2BD87A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088" y="3927475"/>
                <a:ext cx="1479550" cy="0"/>
              </a:xfrm>
              <a:prstGeom prst="line">
                <a:avLst/>
              </a:prstGeom>
              <a:noFill/>
              <a:ln w="4763" cap="flat">
                <a:solidFill>
                  <a:srgbClr val="D7D7D7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8" name="Freeform 65">
                <a:extLst>
                  <a:ext uri="{FF2B5EF4-FFF2-40B4-BE49-F238E27FC236}">
                    <a16:creationId xmlns:a16="http://schemas.microsoft.com/office/drawing/2014/main" id="{A6174A5E-1671-4674-8329-81C982DA6D0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02088" y="3927475"/>
                <a:ext cx="1479550" cy="1485900"/>
              </a:xfrm>
              <a:custGeom>
                <a:avLst/>
                <a:gdLst>
                  <a:gd name="T0" fmla="*/ 13 w 932"/>
                  <a:gd name="T1" fmla="*/ 936 h 936"/>
                  <a:gd name="T2" fmla="*/ 13 w 932"/>
                  <a:gd name="T3" fmla="*/ 832 h 936"/>
                  <a:gd name="T4" fmla="*/ 13 w 932"/>
                  <a:gd name="T5" fmla="*/ 728 h 936"/>
                  <a:gd name="T6" fmla="*/ 25 w 932"/>
                  <a:gd name="T7" fmla="*/ 676 h 936"/>
                  <a:gd name="T8" fmla="*/ 25 w 932"/>
                  <a:gd name="T9" fmla="*/ 572 h 936"/>
                  <a:gd name="T10" fmla="*/ 25 w 932"/>
                  <a:gd name="T11" fmla="*/ 468 h 936"/>
                  <a:gd name="T12" fmla="*/ 25 w 932"/>
                  <a:gd name="T13" fmla="*/ 364 h 936"/>
                  <a:gd name="T14" fmla="*/ 38 w 932"/>
                  <a:gd name="T15" fmla="*/ 312 h 936"/>
                  <a:gd name="T16" fmla="*/ 50 w 932"/>
                  <a:gd name="T17" fmla="*/ 260 h 936"/>
                  <a:gd name="T18" fmla="*/ 75 w 932"/>
                  <a:gd name="T19" fmla="*/ 260 h 936"/>
                  <a:gd name="T20" fmla="*/ 100 w 932"/>
                  <a:gd name="T21" fmla="*/ 260 h 936"/>
                  <a:gd name="T22" fmla="*/ 124 w 932"/>
                  <a:gd name="T23" fmla="*/ 260 h 936"/>
                  <a:gd name="T24" fmla="*/ 149 w 932"/>
                  <a:gd name="T25" fmla="*/ 260 h 936"/>
                  <a:gd name="T26" fmla="*/ 162 w 932"/>
                  <a:gd name="T27" fmla="*/ 208 h 936"/>
                  <a:gd name="T28" fmla="*/ 187 w 932"/>
                  <a:gd name="T29" fmla="*/ 208 h 936"/>
                  <a:gd name="T30" fmla="*/ 199 w 932"/>
                  <a:gd name="T31" fmla="*/ 156 h 936"/>
                  <a:gd name="T32" fmla="*/ 224 w 932"/>
                  <a:gd name="T33" fmla="*/ 156 h 936"/>
                  <a:gd name="T34" fmla="*/ 249 w 932"/>
                  <a:gd name="T35" fmla="*/ 156 h 936"/>
                  <a:gd name="T36" fmla="*/ 274 w 932"/>
                  <a:gd name="T37" fmla="*/ 156 h 936"/>
                  <a:gd name="T38" fmla="*/ 298 w 932"/>
                  <a:gd name="T39" fmla="*/ 156 h 936"/>
                  <a:gd name="T40" fmla="*/ 323 w 932"/>
                  <a:gd name="T41" fmla="*/ 156 h 936"/>
                  <a:gd name="T42" fmla="*/ 348 w 932"/>
                  <a:gd name="T43" fmla="*/ 156 h 936"/>
                  <a:gd name="T44" fmla="*/ 361 w 932"/>
                  <a:gd name="T45" fmla="*/ 104 h 936"/>
                  <a:gd name="T46" fmla="*/ 385 w 932"/>
                  <a:gd name="T47" fmla="*/ 104 h 936"/>
                  <a:gd name="T48" fmla="*/ 398 w 932"/>
                  <a:gd name="T49" fmla="*/ 52 h 936"/>
                  <a:gd name="T50" fmla="*/ 423 w 932"/>
                  <a:gd name="T51" fmla="*/ 52 h 936"/>
                  <a:gd name="T52" fmla="*/ 447 w 932"/>
                  <a:gd name="T53" fmla="*/ 52 h 936"/>
                  <a:gd name="T54" fmla="*/ 472 w 932"/>
                  <a:gd name="T55" fmla="*/ 52 h 936"/>
                  <a:gd name="T56" fmla="*/ 497 w 932"/>
                  <a:gd name="T57" fmla="*/ 52 h 936"/>
                  <a:gd name="T58" fmla="*/ 522 w 932"/>
                  <a:gd name="T59" fmla="*/ 52 h 936"/>
                  <a:gd name="T60" fmla="*/ 547 w 932"/>
                  <a:gd name="T61" fmla="*/ 52 h 936"/>
                  <a:gd name="T62" fmla="*/ 572 w 932"/>
                  <a:gd name="T63" fmla="*/ 52 h 936"/>
                  <a:gd name="T64" fmla="*/ 596 w 932"/>
                  <a:gd name="T65" fmla="*/ 52 h 936"/>
                  <a:gd name="T66" fmla="*/ 621 w 932"/>
                  <a:gd name="T67" fmla="*/ 52 h 936"/>
                  <a:gd name="T68" fmla="*/ 646 w 932"/>
                  <a:gd name="T69" fmla="*/ 52 h 936"/>
                  <a:gd name="T70" fmla="*/ 671 w 932"/>
                  <a:gd name="T71" fmla="*/ 52 h 936"/>
                  <a:gd name="T72" fmla="*/ 696 w 932"/>
                  <a:gd name="T73" fmla="*/ 52 h 936"/>
                  <a:gd name="T74" fmla="*/ 721 w 932"/>
                  <a:gd name="T75" fmla="*/ 52 h 936"/>
                  <a:gd name="T76" fmla="*/ 745 w 932"/>
                  <a:gd name="T77" fmla="*/ 52 h 936"/>
                  <a:gd name="T78" fmla="*/ 758 w 932"/>
                  <a:gd name="T79" fmla="*/ 0 h 936"/>
                  <a:gd name="T80" fmla="*/ 783 w 932"/>
                  <a:gd name="T81" fmla="*/ 0 h 936"/>
                  <a:gd name="T82" fmla="*/ 807 w 932"/>
                  <a:gd name="T83" fmla="*/ 0 h 936"/>
                  <a:gd name="T84" fmla="*/ 832 w 932"/>
                  <a:gd name="T85" fmla="*/ 0 h 936"/>
                  <a:gd name="T86" fmla="*/ 857 w 932"/>
                  <a:gd name="T87" fmla="*/ 0 h 936"/>
                  <a:gd name="T88" fmla="*/ 882 w 932"/>
                  <a:gd name="T89" fmla="*/ 0 h 936"/>
                  <a:gd name="T90" fmla="*/ 907 w 932"/>
                  <a:gd name="T91" fmla="*/ 0 h 936"/>
                  <a:gd name="T92" fmla="*/ 932 w 932"/>
                  <a:gd name="T93" fmla="*/ 0 h 9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932" h="936">
                    <a:moveTo>
                      <a:pt x="0" y="936"/>
                    </a:moveTo>
                    <a:lnTo>
                      <a:pt x="13" y="936"/>
                    </a:lnTo>
                    <a:lnTo>
                      <a:pt x="13" y="884"/>
                    </a:lnTo>
                    <a:lnTo>
                      <a:pt x="13" y="832"/>
                    </a:lnTo>
                    <a:lnTo>
                      <a:pt x="13" y="780"/>
                    </a:lnTo>
                    <a:lnTo>
                      <a:pt x="13" y="728"/>
                    </a:lnTo>
                    <a:lnTo>
                      <a:pt x="13" y="676"/>
                    </a:lnTo>
                    <a:lnTo>
                      <a:pt x="25" y="676"/>
                    </a:lnTo>
                    <a:lnTo>
                      <a:pt x="25" y="624"/>
                    </a:lnTo>
                    <a:lnTo>
                      <a:pt x="25" y="572"/>
                    </a:lnTo>
                    <a:lnTo>
                      <a:pt x="25" y="520"/>
                    </a:lnTo>
                    <a:lnTo>
                      <a:pt x="25" y="468"/>
                    </a:lnTo>
                    <a:lnTo>
                      <a:pt x="25" y="416"/>
                    </a:lnTo>
                    <a:lnTo>
                      <a:pt x="25" y="364"/>
                    </a:lnTo>
                    <a:lnTo>
                      <a:pt x="38" y="364"/>
                    </a:lnTo>
                    <a:lnTo>
                      <a:pt x="38" y="312"/>
                    </a:lnTo>
                    <a:lnTo>
                      <a:pt x="38" y="260"/>
                    </a:lnTo>
                    <a:lnTo>
                      <a:pt x="50" y="260"/>
                    </a:lnTo>
                    <a:lnTo>
                      <a:pt x="62" y="260"/>
                    </a:lnTo>
                    <a:lnTo>
                      <a:pt x="75" y="260"/>
                    </a:lnTo>
                    <a:lnTo>
                      <a:pt x="87" y="260"/>
                    </a:lnTo>
                    <a:lnTo>
                      <a:pt x="100" y="260"/>
                    </a:lnTo>
                    <a:lnTo>
                      <a:pt x="112" y="260"/>
                    </a:lnTo>
                    <a:lnTo>
                      <a:pt x="124" y="260"/>
                    </a:lnTo>
                    <a:lnTo>
                      <a:pt x="137" y="260"/>
                    </a:lnTo>
                    <a:lnTo>
                      <a:pt x="149" y="260"/>
                    </a:lnTo>
                    <a:lnTo>
                      <a:pt x="162" y="260"/>
                    </a:lnTo>
                    <a:lnTo>
                      <a:pt x="162" y="208"/>
                    </a:lnTo>
                    <a:lnTo>
                      <a:pt x="174" y="208"/>
                    </a:lnTo>
                    <a:lnTo>
                      <a:pt x="187" y="208"/>
                    </a:lnTo>
                    <a:lnTo>
                      <a:pt x="187" y="156"/>
                    </a:lnTo>
                    <a:lnTo>
                      <a:pt x="199" y="156"/>
                    </a:lnTo>
                    <a:lnTo>
                      <a:pt x="211" y="156"/>
                    </a:lnTo>
                    <a:lnTo>
                      <a:pt x="224" y="156"/>
                    </a:lnTo>
                    <a:lnTo>
                      <a:pt x="236" y="156"/>
                    </a:lnTo>
                    <a:lnTo>
                      <a:pt x="249" y="156"/>
                    </a:lnTo>
                    <a:lnTo>
                      <a:pt x="261" y="156"/>
                    </a:lnTo>
                    <a:lnTo>
                      <a:pt x="274" y="156"/>
                    </a:lnTo>
                    <a:lnTo>
                      <a:pt x="286" y="156"/>
                    </a:lnTo>
                    <a:lnTo>
                      <a:pt x="298" y="156"/>
                    </a:lnTo>
                    <a:lnTo>
                      <a:pt x="311" y="156"/>
                    </a:lnTo>
                    <a:lnTo>
                      <a:pt x="323" y="156"/>
                    </a:lnTo>
                    <a:lnTo>
                      <a:pt x="336" y="156"/>
                    </a:lnTo>
                    <a:lnTo>
                      <a:pt x="348" y="156"/>
                    </a:lnTo>
                    <a:lnTo>
                      <a:pt x="348" y="104"/>
                    </a:lnTo>
                    <a:lnTo>
                      <a:pt x="361" y="104"/>
                    </a:lnTo>
                    <a:lnTo>
                      <a:pt x="373" y="104"/>
                    </a:lnTo>
                    <a:lnTo>
                      <a:pt x="385" y="104"/>
                    </a:lnTo>
                    <a:lnTo>
                      <a:pt x="398" y="104"/>
                    </a:lnTo>
                    <a:lnTo>
                      <a:pt x="398" y="52"/>
                    </a:lnTo>
                    <a:lnTo>
                      <a:pt x="410" y="52"/>
                    </a:lnTo>
                    <a:lnTo>
                      <a:pt x="423" y="52"/>
                    </a:lnTo>
                    <a:lnTo>
                      <a:pt x="435" y="52"/>
                    </a:lnTo>
                    <a:lnTo>
                      <a:pt x="447" y="52"/>
                    </a:lnTo>
                    <a:lnTo>
                      <a:pt x="460" y="52"/>
                    </a:lnTo>
                    <a:lnTo>
                      <a:pt x="472" y="52"/>
                    </a:lnTo>
                    <a:lnTo>
                      <a:pt x="485" y="52"/>
                    </a:lnTo>
                    <a:lnTo>
                      <a:pt x="497" y="52"/>
                    </a:lnTo>
                    <a:lnTo>
                      <a:pt x="509" y="52"/>
                    </a:lnTo>
                    <a:lnTo>
                      <a:pt x="522" y="52"/>
                    </a:lnTo>
                    <a:lnTo>
                      <a:pt x="534" y="52"/>
                    </a:lnTo>
                    <a:lnTo>
                      <a:pt x="547" y="52"/>
                    </a:lnTo>
                    <a:lnTo>
                      <a:pt x="559" y="52"/>
                    </a:lnTo>
                    <a:lnTo>
                      <a:pt x="572" y="52"/>
                    </a:lnTo>
                    <a:lnTo>
                      <a:pt x="584" y="52"/>
                    </a:lnTo>
                    <a:lnTo>
                      <a:pt x="596" y="52"/>
                    </a:lnTo>
                    <a:lnTo>
                      <a:pt x="609" y="52"/>
                    </a:lnTo>
                    <a:lnTo>
                      <a:pt x="621" y="52"/>
                    </a:lnTo>
                    <a:lnTo>
                      <a:pt x="634" y="52"/>
                    </a:lnTo>
                    <a:lnTo>
                      <a:pt x="646" y="52"/>
                    </a:lnTo>
                    <a:lnTo>
                      <a:pt x="659" y="52"/>
                    </a:lnTo>
                    <a:lnTo>
                      <a:pt x="671" y="52"/>
                    </a:lnTo>
                    <a:lnTo>
                      <a:pt x="683" y="52"/>
                    </a:lnTo>
                    <a:lnTo>
                      <a:pt x="696" y="52"/>
                    </a:lnTo>
                    <a:lnTo>
                      <a:pt x="708" y="52"/>
                    </a:lnTo>
                    <a:lnTo>
                      <a:pt x="721" y="52"/>
                    </a:lnTo>
                    <a:lnTo>
                      <a:pt x="733" y="52"/>
                    </a:lnTo>
                    <a:lnTo>
                      <a:pt x="745" y="52"/>
                    </a:lnTo>
                    <a:lnTo>
                      <a:pt x="745" y="0"/>
                    </a:lnTo>
                    <a:lnTo>
                      <a:pt x="758" y="0"/>
                    </a:lnTo>
                    <a:lnTo>
                      <a:pt x="770" y="0"/>
                    </a:lnTo>
                    <a:lnTo>
                      <a:pt x="783" y="0"/>
                    </a:lnTo>
                    <a:lnTo>
                      <a:pt x="795" y="0"/>
                    </a:lnTo>
                    <a:lnTo>
                      <a:pt x="807" y="0"/>
                    </a:lnTo>
                    <a:lnTo>
                      <a:pt x="820" y="0"/>
                    </a:lnTo>
                    <a:lnTo>
                      <a:pt x="832" y="0"/>
                    </a:lnTo>
                    <a:lnTo>
                      <a:pt x="845" y="0"/>
                    </a:lnTo>
                    <a:lnTo>
                      <a:pt x="857" y="0"/>
                    </a:lnTo>
                    <a:lnTo>
                      <a:pt x="870" y="0"/>
                    </a:lnTo>
                    <a:lnTo>
                      <a:pt x="882" y="0"/>
                    </a:lnTo>
                    <a:lnTo>
                      <a:pt x="895" y="0"/>
                    </a:lnTo>
                    <a:lnTo>
                      <a:pt x="907" y="0"/>
                    </a:lnTo>
                    <a:lnTo>
                      <a:pt x="919" y="0"/>
                    </a:lnTo>
                    <a:lnTo>
                      <a:pt x="932" y="0"/>
                    </a:lnTo>
                    <a:lnTo>
                      <a:pt x="932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9" name="Rectangle 66">
                <a:extLst>
                  <a:ext uri="{FF2B5EF4-FFF2-40B4-BE49-F238E27FC236}">
                    <a16:creationId xmlns:a16="http://schemas.microsoft.com/office/drawing/2014/main" id="{3D031C01-2747-4FB2-93E9-A9AD3E5018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02088" y="3927475"/>
                <a:ext cx="1479550" cy="1485900"/>
              </a:xfrm>
              <a:prstGeom prst="rect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0" name="Line 77">
                <a:extLst>
                  <a:ext uri="{FF2B5EF4-FFF2-40B4-BE49-F238E27FC236}">
                    <a16:creationId xmlns:a16="http://schemas.microsoft.com/office/drawing/2014/main" id="{EEBA4915-6B04-4215-85DA-0CC84D9A8B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2088" y="5413375"/>
                <a:ext cx="0" cy="3175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5" name="Line 82">
                <a:extLst>
                  <a:ext uri="{FF2B5EF4-FFF2-40B4-BE49-F238E27FC236}">
                    <a16:creationId xmlns:a16="http://schemas.microsoft.com/office/drawing/2014/main" id="{32A6EA96-1BDB-4D4A-A7B6-58148C6262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5038" y="5413375"/>
                <a:ext cx="0" cy="3175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0" name="Line 87">
                <a:extLst>
                  <a:ext uri="{FF2B5EF4-FFF2-40B4-BE49-F238E27FC236}">
                    <a16:creationId xmlns:a16="http://schemas.microsoft.com/office/drawing/2014/main" id="{31EE9291-25A2-49FC-B822-6F3E52DA0F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1638" y="5413375"/>
                <a:ext cx="0" cy="31750"/>
              </a:xfrm>
              <a:prstGeom prst="line">
                <a:avLst/>
              </a:prstGeom>
              <a:noFill/>
              <a:ln w="4763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8" name="Rectangle 67">
                <a:extLst>
                  <a:ext uri="{FF2B5EF4-FFF2-40B4-BE49-F238E27FC236}">
                    <a16:creationId xmlns:a16="http://schemas.microsoft.com/office/drawing/2014/main" id="{4CCAAF76-D392-4FEE-BDCA-5B35FB036E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208" y="5349844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9" name="Rectangle 72">
                <a:extLst>
                  <a:ext uri="{FF2B5EF4-FFF2-40B4-BE49-F238E27FC236}">
                    <a16:creationId xmlns:a16="http://schemas.microsoft.com/office/drawing/2014/main" id="{84799401-F06C-46C5-AB42-BF3606CFC4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208" y="4603719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5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" name="Rectangle 77">
                <a:extLst>
                  <a:ext uri="{FF2B5EF4-FFF2-40B4-BE49-F238E27FC236}">
                    <a16:creationId xmlns:a16="http://schemas.microsoft.com/office/drawing/2014/main" id="{278E94E8-420B-4B77-8070-ED76934ED0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208" y="3862357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ctr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1" name="Rectangle 125">
                <a:extLst>
                  <a:ext uri="{FF2B5EF4-FFF2-40B4-BE49-F238E27FC236}">
                    <a16:creationId xmlns:a16="http://schemas.microsoft.com/office/drawing/2014/main" id="{5F542714-2D70-46F1-89F8-0492CC815C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0722" y="5448249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2" name="Rectangle 130">
                <a:extLst>
                  <a:ext uri="{FF2B5EF4-FFF2-40B4-BE49-F238E27FC236}">
                    <a16:creationId xmlns:a16="http://schemas.microsoft.com/office/drawing/2014/main" id="{68256236-D197-4EC4-865B-EBD1E40A15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2494" y="5448249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3" name="Rectangle 72">
                <a:extLst>
                  <a:ext uri="{FF2B5EF4-FFF2-40B4-BE49-F238E27FC236}">
                    <a16:creationId xmlns:a16="http://schemas.microsoft.com/office/drawing/2014/main" id="{A269BB2B-F5A0-41D5-BE1E-C502964515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2045" y="5442216"/>
                <a:ext cx="184346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9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5</a:t>
                </a:r>
                <a:endPara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4" name="Rectangle 37">
                <a:extLst>
                  <a:ext uri="{FF2B5EF4-FFF2-40B4-BE49-F238E27FC236}">
                    <a16:creationId xmlns:a16="http://schemas.microsoft.com/office/drawing/2014/main" id="{07395DD4-87E0-471A-9209-BAB9C2B951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11368" y="5730003"/>
                <a:ext cx="68929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1-Specificity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155" name="Rectangle 6">
                <a:extLst>
                  <a:ext uri="{FF2B5EF4-FFF2-40B4-BE49-F238E27FC236}">
                    <a16:creationId xmlns:a16="http://schemas.microsoft.com/office/drawing/2014/main" id="{1F613190-968A-4A45-949E-7A994E2625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345693" y="4600590"/>
                <a:ext cx="57547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000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S</a:t>
                </a:r>
                <a:r>
                  <a:rPr kumimoji="0" lang="en-US" altLang="ja-JP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ensitivity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17449885-B355-4F34-8296-AEA96E6C2388}"/>
                </a:ext>
              </a:extLst>
            </p:cNvPr>
            <p:cNvSpPr txBox="1"/>
            <p:nvPr/>
          </p:nvSpPr>
          <p:spPr>
            <a:xfrm>
              <a:off x="4419038" y="4938965"/>
              <a:ext cx="104547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/>
                <a:t>AUC: </a:t>
              </a:r>
              <a:br>
                <a:rPr kumimoji="1" lang="en-US" altLang="ja-JP" sz="1000" dirty="0"/>
              </a:br>
              <a:r>
                <a:rPr lang="en-US" altLang="ja-JP" sz="1000" dirty="0"/>
                <a:t>0.87 [0.73–0.95]</a:t>
              </a:r>
              <a:endParaRPr kumimoji="1" lang="ja-JP" altLang="en-US" sz="1000" dirty="0"/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57914935-B1E1-49A9-B1C8-C4C22C59761C}"/>
                </a:ext>
              </a:extLst>
            </p:cNvPr>
            <p:cNvSpPr txBox="1"/>
            <p:nvPr/>
          </p:nvSpPr>
          <p:spPr>
            <a:xfrm>
              <a:off x="960579" y="3546979"/>
              <a:ext cx="3257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F520AECC-98FC-44FB-A94F-8901EEE1F907}"/>
                </a:ext>
              </a:extLst>
            </p:cNvPr>
            <p:cNvSpPr txBox="1"/>
            <p:nvPr/>
          </p:nvSpPr>
          <p:spPr>
            <a:xfrm>
              <a:off x="3431880" y="3540978"/>
              <a:ext cx="3257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84E26A80-F222-4DAD-8D1F-2E974B155FFC}"/>
              </a:ext>
            </a:extLst>
          </p:cNvPr>
          <p:cNvSpPr txBox="1"/>
          <p:nvPr/>
        </p:nvSpPr>
        <p:spPr>
          <a:xfrm>
            <a:off x="478721" y="9069669"/>
            <a:ext cx="22862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Figure</a:t>
            </a:r>
            <a:r>
              <a:rPr lang="ja-JP" altLang="en-US" dirty="0"/>
              <a:t> </a:t>
            </a:r>
            <a:r>
              <a:rPr lang="en-US" altLang="ja-JP" dirty="0"/>
              <a:t>2</a:t>
            </a:r>
          </a:p>
          <a:p>
            <a:r>
              <a:rPr lang="en-US" altLang="ja-JP" dirty="0"/>
              <a:t>Matsuura R, et al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19268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</TotalTime>
  <Words>79</Words>
  <Application>Microsoft Office PowerPoint</Application>
  <PresentationFormat>A4 210 x 297 mm</PresentationFormat>
  <Paragraphs>4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Arial Unicode MS</vt:lpstr>
      <vt:lpstr>メイリオ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浦亮</dc:creator>
  <cp:lastModifiedBy>松浦亮</cp:lastModifiedBy>
  <cp:revision>6</cp:revision>
  <dcterms:created xsi:type="dcterms:W3CDTF">2017-06-22T13:26:56Z</dcterms:created>
  <dcterms:modified xsi:type="dcterms:W3CDTF">2017-06-22T14:22:49Z</dcterms:modified>
</cp:coreProperties>
</file>